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A7017-6EB6-41DB-9C8D-261DEF87C3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4A5A3-3D7F-4CCD-BC5D-553C500EE7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542DB-5DF1-4713-9792-5E09125A67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09542-80F0-47CA-8044-B645DF042E6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3EA441-D342-4CDF-9E01-772A2D5595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E6AA75-00CA-4CD5-961E-A43853BF5E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867DBA-DDE6-48E4-B04A-23ED94BDEC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109D5C-CFE8-4B2D-9133-742763268F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A61EB-9F61-4252-8FD6-20355F01CE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AE7245-E46C-4C7A-A6C1-E6B2DB4202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5889C-AB20-4CED-B310-B683EF69ED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018A09-18C9-4775-9FC0-C84C30BBFC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C0D0C4-8445-4060-B8C9-4A5D595BD6B6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530280" y="1878120"/>
            <a:ext cx="3108240" cy="160164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530280" y="525600"/>
            <a:ext cx="3108240" cy="13237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3351240" y="1690560"/>
            <a:ext cx="1285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351240" y="3367080"/>
            <a:ext cx="12852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5" name="" descr=""/>
          <p:cNvPicPr/>
          <p:nvPr/>
        </p:nvPicPr>
        <p:blipFill>
          <a:blip r:embed="rId3">
            <a:lum contrast="6000"/>
          </a:blip>
          <a:srcRect l="0" t="15174" r="0" b="0"/>
          <a:stretch/>
        </p:blipFill>
        <p:spPr>
          <a:xfrm>
            <a:off x="3676680" y="4908600"/>
            <a:ext cx="2571840" cy="157320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3797280" y="6370560"/>
            <a:ext cx="152280" cy="180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-1417680" y="5130720"/>
            <a:ext cx="5610240" cy="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8" name="" descr=""/>
          <p:cNvPicPr/>
          <p:nvPr/>
        </p:nvPicPr>
        <p:blipFill>
          <a:blip r:embed="rId4">
            <a:lum contrast="8000"/>
          </a:blip>
          <a:srcRect l="0" t="29408" r="1634" b="0"/>
          <a:stretch/>
        </p:blipFill>
        <p:spPr>
          <a:xfrm>
            <a:off x="3675240" y="3537000"/>
            <a:ext cx="2574720" cy="134280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3784680" y="4809960"/>
            <a:ext cx="152280" cy="180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0" name="" descr=""/>
          <p:cNvPicPr/>
          <p:nvPr/>
        </p:nvPicPr>
        <p:blipFill>
          <a:blip r:embed="rId5"/>
          <a:srcRect l="0" t="0" r="5314" b="0"/>
          <a:stretch/>
        </p:blipFill>
        <p:spPr>
          <a:xfrm>
            <a:off x="3668760" y="2039760"/>
            <a:ext cx="2574720" cy="144972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6"/>
          <a:srcRect l="0" t="0" r="5951" b="0"/>
          <a:stretch/>
        </p:blipFill>
        <p:spPr>
          <a:xfrm>
            <a:off x="3668760" y="520560"/>
            <a:ext cx="2558880" cy="148140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3726000" y="1908000"/>
            <a:ext cx="11880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3726000" y="3373560"/>
            <a:ext cx="11880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4" name="" descr=""/>
          <p:cNvPicPr/>
          <p:nvPr/>
        </p:nvPicPr>
        <p:blipFill>
          <a:blip r:embed="rId7"/>
          <a:stretch/>
        </p:blipFill>
        <p:spPr>
          <a:xfrm>
            <a:off x="542880" y="3529080"/>
            <a:ext cx="3105360" cy="132876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8"/>
          <a:stretch/>
        </p:blipFill>
        <p:spPr>
          <a:xfrm>
            <a:off x="542880" y="4897440"/>
            <a:ext cx="3105360" cy="158436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3335400" y="6354720"/>
            <a:ext cx="128520" cy="180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3335400" y="4794120"/>
            <a:ext cx="1285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515880" y="6732000"/>
            <a:ext cx="568476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l Figure 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. Microscopic analysis of root cross-sections (A, B, E, F, G, H) or lateral roots (C, D) from 4-week-ol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B. junce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transformed with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p BjMTP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::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RFP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(A, B, C, D, E, F) or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p BjMTP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::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EYFP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(G,H),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fter exposure to 5 µM Cd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2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(E, F) or 50 µM Ni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2+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(G, H) for 48 h . Transgenic plants not treated with either Cd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2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or Ni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2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were used as controls (A, B, C, D, G). Images taken under bright field illumination, using diascopic filters at 10X (A, C, E), and fluorescent images using a Rhodamine - Texas red filter (B, D, F) and a GFP filter (G, H) both at 10X magnification. Scale bar = 40 µm. Exposure are 6 s (B, D, G), 100 ms (F) and 250 ms (H)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3225960" y="48744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3225960" y="18730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5798160" y="48744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5798160" y="203364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3225960" y="351324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5781240" y="3513240"/>
            <a:ext cx="418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G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3243240" y="4884840"/>
            <a:ext cx="366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5798160" y="488484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1-16T18:57:16Z</dcterms:created>
  <dc:creator>muthukumar</dc:creator>
  <dc:description/>
  <dc:language>en-US</dc:language>
  <cp:lastModifiedBy>dsalt</cp:lastModifiedBy>
  <dcterms:modified xsi:type="dcterms:W3CDTF">2006-11-21T14:58:25Z</dcterms:modified>
  <cp:revision>28</cp:revision>
  <dc:subject/>
  <dc:title>PowerPoint Presentation</dc:title>
</cp:coreProperties>
</file>